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264275" cy="8423275"/>
  <p:notesSz cx="6858000" cy="9144000"/>
  <p:defaultTextStyle>
    <a:defPPr>
      <a:defRPr lang="en-US"/>
    </a:defPPr>
    <a:lvl1pPr marL="0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1pPr>
    <a:lvl2pPr marL="400553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2pPr>
    <a:lvl3pPr marL="801106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3pPr>
    <a:lvl4pPr marL="1201659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4pPr>
    <a:lvl5pPr marL="1602212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5pPr>
    <a:lvl6pPr marL="2002765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6pPr>
    <a:lvl7pPr marL="2403318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7pPr>
    <a:lvl8pPr marL="2803870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8pPr>
    <a:lvl9pPr marL="3204423" algn="l" defTabSz="801106" rtl="0" eaLnBrk="1" latinLnBrk="0" hangingPunct="1">
      <a:defRPr sz="157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3" userDrawn="1">
          <p15:clr>
            <a:srgbClr val="A4A3A4"/>
          </p15:clr>
        </p15:guide>
        <p15:guide id="2" pos="174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2098" y="86"/>
      </p:cViewPr>
      <p:guideLst>
        <p:guide orient="horz" pos="223"/>
        <p:guide pos="174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308239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793700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47809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559880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6667133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23989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479594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29496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93562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942725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28299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0E6112-60D8-4E08-9D1D-6C513A847DDB}" type="datetimeFigureOut">
              <a:rPr lang="en-AU" smtClean="0"/>
              <a:t>15/09/2018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910109-5C1F-4E17-A5EA-EDC54C316562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77596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0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0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0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0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/>
          <p:cNvGrpSpPr/>
          <p:nvPr/>
        </p:nvGrpSpPr>
        <p:grpSpPr>
          <a:xfrm>
            <a:off x="546374" y="72806"/>
            <a:ext cx="5295337" cy="8242223"/>
            <a:chOff x="546374" y="72806"/>
            <a:chExt cx="5295337" cy="8242223"/>
          </a:xfrm>
        </p:grpSpPr>
        <p:sp>
          <p:nvSpPr>
            <p:cNvPr id="47" name="Rectangle 46"/>
            <p:cNvSpPr/>
            <p:nvPr/>
          </p:nvSpPr>
          <p:spPr>
            <a:xfrm>
              <a:off x="2631400" y="72806"/>
              <a:ext cx="2216084" cy="19319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AU" sz="1341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546374" y="7647154"/>
              <a:ext cx="5295337" cy="6678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AU" sz="68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AU" sz="1020" b="1" dirty="0">
                  <a:latin typeface="Arial" panose="020B0604020202020204" pitchFamily="34" charset="0"/>
                  <a:cs typeface="Arial" panose="020B0604020202020204" pitchFamily="34" charset="0"/>
                </a:rPr>
                <a:t>Online Resource </a:t>
              </a:r>
              <a:r>
                <a:rPr lang="en-AU" sz="1020" b="1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r>
                <a:rPr lang="en-AU" sz="102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AU" sz="1020" dirty="0"/>
                <a:t>Population stratification among 231 wild and domesticated accessions of narrow-leafed lupin using </a:t>
              </a:r>
              <a:r>
                <a:rPr lang="en-AU" sz="1020" dirty="0" err="1"/>
                <a:t>fastSTRUCTURE</a:t>
              </a:r>
              <a:r>
                <a:rPr lang="en-AU" sz="1020" dirty="0"/>
                <a:t> for K=2 – 12. Each colour denotes a population affiliation. Note that colours are not equivalent between panels</a:t>
              </a:r>
              <a:endParaRPr lang="en-AU" sz="102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" name="Straight Connector 2"/>
            <p:cNvCxnSpPr/>
            <p:nvPr/>
          </p:nvCxnSpPr>
          <p:spPr>
            <a:xfrm>
              <a:off x="684904" y="158438"/>
              <a:ext cx="17442" cy="7084565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2790204" y="214100"/>
              <a:ext cx="20618" cy="7033862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4964812" y="227460"/>
              <a:ext cx="462" cy="69167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" name="Group 8"/>
            <p:cNvGrpSpPr/>
            <p:nvPr/>
          </p:nvGrpSpPr>
          <p:grpSpPr>
            <a:xfrm>
              <a:off x="749484" y="158437"/>
              <a:ext cx="4122675" cy="7281422"/>
              <a:chOff x="604584" y="199221"/>
              <a:chExt cx="4848378" cy="8563150"/>
            </a:xfrm>
          </p:grpSpPr>
          <p:grpSp>
            <p:nvGrpSpPr>
              <p:cNvPr id="2" name="Group 1"/>
              <p:cNvGrpSpPr/>
              <p:nvPr/>
            </p:nvGrpSpPr>
            <p:grpSpPr>
              <a:xfrm>
                <a:off x="836432" y="199221"/>
                <a:ext cx="3091589" cy="7405768"/>
                <a:chOff x="716260" y="79429"/>
                <a:chExt cx="3091589" cy="7891502"/>
              </a:xfrm>
            </p:grpSpPr>
            <p:sp>
              <p:nvSpPr>
                <p:cNvPr id="54" name="TextBox 53"/>
                <p:cNvSpPr txBox="1"/>
                <p:nvPr/>
              </p:nvSpPr>
              <p:spPr>
                <a:xfrm>
                  <a:off x="721076" y="89904"/>
                  <a:ext cx="488637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2</a:t>
                  </a:r>
                </a:p>
              </p:txBody>
            </p:sp>
            <p:sp>
              <p:nvSpPr>
                <p:cNvPr id="55" name="TextBox 54"/>
                <p:cNvSpPr txBox="1"/>
                <p:nvPr/>
              </p:nvSpPr>
              <p:spPr>
                <a:xfrm>
                  <a:off x="716260" y="1439428"/>
                  <a:ext cx="488637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3</a:t>
                  </a:r>
                </a:p>
              </p:txBody>
            </p:sp>
            <p:sp>
              <p:nvSpPr>
                <p:cNvPr id="56" name="TextBox 55"/>
                <p:cNvSpPr txBox="1"/>
                <p:nvPr/>
              </p:nvSpPr>
              <p:spPr>
                <a:xfrm>
                  <a:off x="716260" y="2976581"/>
                  <a:ext cx="488637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4</a:t>
                  </a:r>
                </a:p>
              </p:txBody>
            </p:sp>
            <p:sp>
              <p:nvSpPr>
                <p:cNvPr id="57" name="TextBox 56"/>
                <p:cNvSpPr txBox="1"/>
                <p:nvPr/>
              </p:nvSpPr>
              <p:spPr>
                <a:xfrm>
                  <a:off x="771108" y="4620721"/>
                  <a:ext cx="488637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5</a:t>
                  </a:r>
                </a:p>
              </p:txBody>
            </p:sp>
            <p:sp>
              <p:nvSpPr>
                <p:cNvPr id="58" name="TextBox 57"/>
                <p:cNvSpPr txBox="1"/>
                <p:nvPr/>
              </p:nvSpPr>
              <p:spPr>
                <a:xfrm>
                  <a:off x="804674" y="6227199"/>
                  <a:ext cx="488637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6</a:t>
                  </a: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>
                <a:xfrm>
                  <a:off x="772640" y="7625735"/>
                  <a:ext cx="488637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7</a:t>
                  </a:r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>
                <a:xfrm>
                  <a:off x="3130170" y="79429"/>
                  <a:ext cx="488637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8</a:t>
                  </a:r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>
                <a:xfrm>
                  <a:off x="3178812" y="1434354"/>
                  <a:ext cx="488637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9</a:t>
                  </a:r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>
                  <a:off x="3178812" y="2965132"/>
                  <a:ext cx="579126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10</a:t>
                  </a: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3206047" y="4618061"/>
                  <a:ext cx="579126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11</a:t>
                  </a: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3228723" y="6198850"/>
                  <a:ext cx="579126" cy="34519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AU" sz="1190" dirty="0"/>
                    <a:t>K=12</a:t>
                  </a:r>
                </a:p>
              </p:txBody>
            </p:sp>
          </p:grpSp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48142" y="427801"/>
                <a:ext cx="2255592" cy="1142519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04584" y="1810552"/>
                <a:ext cx="2326419" cy="1112375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8968" y="3211846"/>
                <a:ext cx="2340739" cy="1161297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73557" y="4780812"/>
                <a:ext cx="2276907" cy="1086844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68773" y="6217095"/>
                <a:ext cx="2320102" cy="1150770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92490" y="7640163"/>
                <a:ext cx="2293745" cy="1122208"/>
              </a:xfrm>
              <a:prstGeom prst="rect">
                <a:avLst/>
              </a:prstGeom>
            </p:spPr>
          </p:pic>
          <p:pic>
            <p:nvPicPr>
              <p:cNvPr id="21" name="Picture 20"/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51933" y="480504"/>
                <a:ext cx="2179631" cy="1089816"/>
              </a:xfrm>
              <a:prstGeom prst="rect">
                <a:avLst/>
              </a:prstGeom>
            </p:spPr>
          </p:pic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67195" y="1827018"/>
                <a:ext cx="2164369" cy="1091031"/>
              </a:xfrm>
              <a:prstGeom prst="rect">
                <a:avLst/>
              </a:prstGeom>
            </p:spPr>
          </p:pic>
          <p:pic>
            <p:nvPicPr>
              <p:cNvPr id="23" name="Picture 22"/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77086" y="3274845"/>
                <a:ext cx="2222260" cy="1078007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74267" y="4764162"/>
                <a:ext cx="2225079" cy="1103494"/>
              </a:xfrm>
              <a:prstGeom prst="rect">
                <a:avLst/>
              </a:prstGeom>
            </p:spPr>
          </p:pic>
          <p:pic>
            <p:nvPicPr>
              <p:cNvPr id="25" name="Picture 24"/>
              <p:cNvPicPr>
                <a:picLocks noChangeAspect="1"/>
              </p:cNvPicPr>
              <p:nvPr/>
            </p:nvPicPr>
            <p:blipFill>
              <a:blip r:embed="rId1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173760" y="6270172"/>
                <a:ext cx="2279202" cy="1105994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6166499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6</TotalTime>
  <Words>47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sa Mousaviderazmahalleh</dc:creator>
  <cp:lastModifiedBy>Mahsa Mousaviderazmahalleh</cp:lastModifiedBy>
  <cp:revision>42</cp:revision>
  <dcterms:created xsi:type="dcterms:W3CDTF">2016-11-04T04:41:02Z</dcterms:created>
  <dcterms:modified xsi:type="dcterms:W3CDTF">2018-09-15T08:47:40Z</dcterms:modified>
</cp:coreProperties>
</file>